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2" d="100"/>
          <a:sy n="7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ola Olapeju" userId="f543be55-eb40-4fd9-93eb-11718ae846ed" providerId="ADAL" clId="{6462B395-60D6-4E80-93A8-61908C7C811F}"/>
    <pc:docChg chg="custSel modSld">
      <pc:chgData name="Bola Olapeju" userId="f543be55-eb40-4fd9-93eb-11718ae846ed" providerId="ADAL" clId="{6462B395-60D6-4E80-93A8-61908C7C811F}" dt="2022-03-15T14:28:37.142" v="5" actId="113"/>
      <pc:docMkLst>
        <pc:docMk/>
      </pc:docMkLst>
      <pc:sldChg chg="delSp modSp mod">
        <pc:chgData name="Bola Olapeju" userId="f543be55-eb40-4fd9-93eb-11718ae846ed" providerId="ADAL" clId="{6462B395-60D6-4E80-93A8-61908C7C811F}" dt="2022-03-15T14:28:37.142" v="5" actId="113"/>
        <pc:sldMkLst>
          <pc:docMk/>
          <pc:sldMk cId="4262140478" sldId="257"/>
        </pc:sldMkLst>
        <pc:spChg chg="mod">
          <ac:chgData name="Bola Olapeju" userId="f543be55-eb40-4fd9-93eb-11718ae846ed" providerId="ADAL" clId="{6462B395-60D6-4E80-93A8-61908C7C811F}" dt="2022-03-15T14:28:37.142" v="5" actId="113"/>
          <ac:spMkLst>
            <pc:docMk/>
            <pc:sldMk cId="4262140478" sldId="257"/>
            <ac:spMk id="2" creationId="{5A972DD1-456C-4D9A-9A19-89F8E7A7E609}"/>
          </ac:spMkLst>
        </pc:spChg>
        <pc:spChg chg="del">
          <ac:chgData name="Bola Olapeju" userId="f543be55-eb40-4fd9-93eb-11718ae846ed" providerId="ADAL" clId="{6462B395-60D6-4E80-93A8-61908C7C811F}" dt="2022-03-15T14:27:22.119" v="2" actId="478"/>
          <ac:spMkLst>
            <pc:docMk/>
            <pc:sldMk cId="4262140478" sldId="257"/>
            <ac:spMk id="3" creationId="{9ED0A653-C30F-462F-81C7-24389774FF8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F7A79-EA49-4137-A143-F26425F22D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68EA00-AC3E-405B-AB3A-056E8EF814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E69E8-6E42-461F-9BCF-35B689145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A6FC54-5D53-43E6-9A82-CDD2C570F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EC4CE9-38A6-451D-91AB-1496B53E3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692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526F15-A5F3-45E7-B2A3-CEF8CDB30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8D44CD-3C01-4FA7-86F7-7782A9F6FF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519195-5F31-434C-B318-587064EB2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0727F5-9158-4FFA-B581-4D196A656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C07C63-95F4-4C38-851C-BCCA9FC6CD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675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B1EBD7-E0FF-4C70-965F-C3CFE0CBFB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95B127-B46B-41AE-9B23-C8B5B33210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E86A4E-267E-4357-8014-FBD725B17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0109D8-F8BF-44C9-8593-86ED6B36E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F1BC64-9DC0-4AD2-B6E7-3C15233DE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412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27EEEA-0D9F-4EEC-B25F-C9BB3B385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F44977-36A3-4A00-9747-D08CD0EC93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52D90F-8CA3-4618-A112-329C626EE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8F21C-81DD-45A2-96D3-E31A46B1B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EAAE29-A1CD-4D1A-B67E-04BED4B46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268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598CD-588D-4A4E-9583-693D44C276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E0D6D4-2CEF-45AF-9232-30EE878B0D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E518B4-6AD3-4824-8888-E974E4C6E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607291-7BCC-4324-B027-EA54F3C0C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7814B7-EB33-422A-9B68-BED073C23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360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D7AF9A-890E-477E-88A9-A183D6071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2D6A2-1C1E-44D7-BA66-B1F863F014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29EE6D-0937-4CF0-9565-001144C0C3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34C085-27D3-4F48-949A-008FFDF0A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D1D79F-8DDF-4065-B122-C73FA3C5C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663984-3FB0-4FB1-83CC-D5439DE6A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171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D5F1A4-51FB-4641-9BA7-46E6568FDE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B25059-16B4-4E60-8E73-C46FEE1DA4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1D587A-3EB2-4F8C-8192-8D8CD2E365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177366-D3A2-4C18-8F94-F9ACA10530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8DD796-BE24-48A2-8EF4-E516230CE4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075314-37CB-420B-8B5B-00D57CDFA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C246EFA-5EE0-44F8-B311-0F8FB6717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A14BDD9-79F7-41C3-A9A3-9144439B03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471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B7AF1-35D2-41A0-81C5-FF0AA9550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0EEF39-01D3-4F2B-B9CB-FD8243ECB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31D601-03FB-47AB-A96E-3D12BEB99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C14869-7587-4766-A724-82FAEF5CC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578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83BF02-53C3-427B-964A-096D92580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EA4033-AB7E-435B-8C67-C784F52E1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20EE52-B35C-4413-AAEC-379C86569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000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857518-3114-496E-BCE1-FD8791DB8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9AC7F7-3302-4444-8D93-2B4BEB8A90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001956-E7B8-409E-B115-D651FF8413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46C827-0836-45C5-B51B-510FE8487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758C30-FE8A-40FC-9542-911786654F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A6880C-EF8C-430E-B8A3-C0F8B67FE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483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4ECBB5-86ED-42C3-AF63-A748466D65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409115-48F3-43B8-8E0A-E83ECE1302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62CDC7-CB86-4BC8-91CC-8F2BCBD8C4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709A9C-8152-470C-BD6A-F983A36B7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F0E2F4-5DD6-4C10-A83E-45C4D822A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953624-7D1F-4A4C-9CD6-A318F5644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928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2986D06-FF1F-44D8-B122-E8A268C58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1EE22A-ACFA-472B-BA0C-9CC2F01623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E72DB7-FEA1-46A2-B3AD-791B22AE0E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7F8DA-FEF1-4932-ADDB-65BF652806BD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8DA0D7-EE08-4CAA-A952-17EF590BFB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67EEA9-CB8A-443C-A9A0-A8DF2E7AC8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846BE5-C4E9-4F91-8885-1EFFF0326B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317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972DD1-456C-4D9A-9A19-89F8E7A7E6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70722" y="1743351"/>
            <a:ext cx="10515600" cy="1325563"/>
          </a:xfrm>
        </p:spPr>
        <p:txBody>
          <a:bodyPr>
            <a:noAutofit/>
          </a:bodyPr>
          <a:lstStyle/>
          <a:p>
            <a:r>
              <a:rPr lang="en-US" sz="2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1</a:t>
            </a:r>
            <a:br>
              <a:rPr lang="en-US" sz="2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br>
              <a:rPr lang="en-US" sz="2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r>
              <a:rPr lang="en-US" sz="2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rief Figure Title: </a:t>
            </a:r>
            <a:r>
              <a:rPr lang="en-US" sz="2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udy Participants Flow Chart</a:t>
            </a:r>
            <a:br>
              <a:rPr lang="en-US" sz="2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r>
              <a:rPr lang="en-US" sz="2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egend:</a:t>
            </a:r>
            <a:r>
              <a:rPr lang="en-US" sz="2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2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Flow diagram of participants included in the study</a:t>
            </a:r>
            <a:br>
              <a:rPr lang="en-US" sz="2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endParaRPr lang="en-US" sz="4800" dirty="0"/>
          </a:p>
        </p:txBody>
      </p:sp>
    </p:spTree>
    <p:extLst>
      <p:ext uri="{BB962C8B-B14F-4D97-AF65-F5344CB8AC3E}">
        <p14:creationId xmlns:p14="http://schemas.microsoft.com/office/powerpoint/2010/main" val="42621404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>
            <a:extLst>
              <a:ext uri="{FF2B5EF4-FFF2-40B4-BE49-F238E27FC236}">
                <a16:creationId xmlns:a16="http://schemas.microsoft.com/office/drawing/2014/main" id="{0DCC1A4E-BFD3-426E-8B59-52AC7CFC2E03}"/>
              </a:ext>
            </a:extLst>
          </p:cNvPr>
          <p:cNvGrpSpPr/>
          <p:nvPr/>
        </p:nvGrpSpPr>
        <p:grpSpPr>
          <a:xfrm>
            <a:off x="3888923" y="444138"/>
            <a:ext cx="5087713" cy="5126009"/>
            <a:chOff x="3888923" y="444138"/>
            <a:chExt cx="5087713" cy="5126009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9A96993C-B345-4B97-A7E0-A30B9A547CC1}"/>
                </a:ext>
              </a:extLst>
            </p:cNvPr>
            <p:cNvGrpSpPr/>
            <p:nvPr/>
          </p:nvGrpSpPr>
          <p:grpSpPr>
            <a:xfrm>
              <a:off x="3888923" y="444138"/>
              <a:ext cx="5087713" cy="5126009"/>
              <a:chOff x="4012074" y="409303"/>
              <a:chExt cx="5087713" cy="5126009"/>
            </a:xfrm>
          </p:grpSpPr>
          <p:sp>
            <p:nvSpPr>
              <p:cNvPr id="18" name="Text Box 1">
                <a:extLst>
                  <a:ext uri="{FF2B5EF4-FFF2-40B4-BE49-F238E27FC236}">
                    <a16:creationId xmlns:a16="http://schemas.microsoft.com/office/drawing/2014/main" id="{EE09C834-0766-4664-BDBE-641BEEDD8563}"/>
                  </a:ext>
                </a:extLst>
              </p:cNvPr>
              <p:cNvSpPr txBox="1"/>
              <p:nvPr/>
            </p:nvSpPr>
            <p:spPr>
              <a:xfrm>
                <a:off x="5453062" y="1602921"/>
                <a:ext cx="1645920" cy="73152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4543 women aged 15-49 years enrolled into study</a:t>
                </a:r>
              </a:p>
            </p:txBody>
          </p:sp>
          <p:sp>
            <p:nvSpPr>
              <p:cNvPr id="19" name="Text Box 2">
                <a:extLst>
                  <a:ext uri="{FF2B5EF4-FFF2-40B4-BE49-F238E27FC236}">
                    <a16:creationId xmlns:a16="http://schemas.microsoft.com/office/drawing/2014/main" id="{207C1302-A193-4EFF-BBB8-1F6074823F08}"/>
                  </a:ext>
                </a:extLst>
              </p:cNvPr>
              <p:cNvSpPr txBox="1"/>
              <p:nvPr/>
            </p:nvSpPr>
            <p:spPr>
              <a:xfrm>
                <a:off x="4012074" y="409303"/>
                <a:ext cx="1645920" cy="73152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770 women aged 15-49 years enrolled at baseline survey</a:t>
                </a:r>
              </a:p>
            </p:txBody>
          </p:sp>
          <p:sp>
            <p:nvSpPr>
              <p:cNvPr id="20" name="Text Box 3">
                <a:extLst>
                  <a:ext uri="{FF2B5EF4-FFF2-40B4-BE49-F238E27FC236}">
                    <a16:creationId xmlns:a16="http://schemas.microsoft.com/office/drawing/2014/main" id="{6478A74F-6D60-4DFE-B8D2-DC7F2B1309DB}"/>
                  </a:ext>
                </a:extLst>
              </p:cNvPr>
              <p:cNvSpPr txBox="1"/>
              <p:nvPr/>
            </p:nvSpPr>
            <p:spPr>
              <a:xfrm>
                <a:off x="6767512" y="409303"/>
                <a:ext cx="1645920" cy="73152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1773 women aged 15-49 years enrolled at follow-up survey</a:t>
                </a:r>
              </a:p>
            </p:txBody>
          </p:sp>
          <p:sp>
            <p:nvSpPr>
              <p:cNvPr id="21" name="Text Box 6">
                <a:extLst>
                  <a:ext uri="{FF2B5EF4-FFF2-40B4-BE49-F238E27FC236}">
                    <a16:creationId xmlns:a16="http://schemas.microsoft.com/office/drawing/2014/main" id="{D1D5E753-4BC3-473C-8FD3-D387B2116FD6}"/>
                  </a:ext>
                </a:extLst>
              </p:cNvPr>
              <p:cNvSpPr txBox="1"/>
              <p:nvPr/>
            </p:nvSpPr>
            <p:spPr>
              <a:xfrm>
                <a:off x="7453867" y="4037168"/>
                <a:ext cx="1645920" cy="73152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1974 caregivers of children under five without fever excluded</a:t>
                </a:r>
              </a:p>
            </p:txBody>
          </p:sp>
          <p:sp>
            <p:nvSpPr>
              <p:cNvPr id="24" name="Text Box 7">
                <a:extLst>
                  <a:ext uri="{FF2B5EF4-FFF2-40B4-BE49-F238E27FC236}">
                    <a16:creationId xmlns:a16="http://schemas.microsoft.com/office/drawing/2014/main" id="{AF42ED9C-93E5-4540-9884-428F3B4638DC}"/>
                  </a:ext>
                </a:extLst>
              </p:cNvPr>
              <p:cNvSpPr txBox="1"/>
              <p:nvPr/>
            </p:nvSpPr>
            <p:spPr>
              <a:xfrm>
                <a:off x="5484773" y="4803792"/>
                <a:ext cx="1645920" cy="73152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479 caregivers of children under five with fever</a:t>
                </a:r>
              </a:p>
            </p:txBody>
          </p:sp>
          <p:sp>
            <p:nvSpPr>
              <p:cNvPr id="26" name="Text Box 5">
                <a:extLst>
                  <a:ext uri="{FF2B5EF4-FFF2-40B4-BE49-F238E27FC236}">
                    <a16:creationId xmlns:a16="http://schemas.microsoft.com/office/drawing/2014/main" id="{67CB37E6-2ACC-4350-8FA7-7F7C4DCCE329}"/>
                  </a:ext>
                </a:extLst>
              </p:cNvPr>
              <p:cNvSpPr txBox="1"/>
              <p:nvPr/>
            </p:nvSpPr>
            <p:spPr>
              <a:xfrm>
                <a:off x="5484773" y="3262242"/>
                <a:ext cx="1645920" cy="73152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453 caregivers of children under five</a:t>
                </a:r>
              </a:p>
            </p:txBody>
          </p:sp>
        </p:grp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67C8AAD9-4CE1-47CF-B838-975A2A49D7AE}"/>
                </a:ext>
              </a:extLst>
            </p:cNvPr>
            <p:cNvCxnSpPr>
              <a:stCxn id="18" idx="2"/>
              <a:endCxn id="26" idx="0"/>
            </p:cNvCxnSpPr>
            <p:nvPr/>
          </p:nvCxnSpPr>
          <p:spPr>
            <a:xfrm>
              <a:off x="6152871" y="2369276"/>
              <a:ext cx="0" cy="9144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504CF174-90CF-4AB9-97AB-EA0E552AE5C2}"/>
                </a:ext>
              </a:extLst>
            </p:cNvPr>
            <p:cNvCxnSpPr>
              <a:cxnSpLocks/>
            </p:cNvCxnSpPr>
            <p:nvPr/>
          </p:nvCxnSpPr>
          <p:spPr>
            <a:xfrm>
              <a:off x="5547360" y="718458"/>
              <a:ext cx="10972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0D2DA803-F06A-4A9A-9D49-144FC620A36D}"/>
                </a:ext>
              </a:extLst>
            </p:cNvPr>
            <p:cNvCxnSpPr>
              <a:endCxn id="18" idx="0"/>
            </p:cNvCxnSpPr>
            <p:nvPr/>
          </p:nvCxnSpPr>
          <p:spPr>
            <a:xfrm>
              <a:off x="6061431" y="718458"/>
              <a:ext cx="0" cy="9144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92A389ED-78F1-48A8-A2FE-2A1DAA7C0C13}"/>
                </a:ext>
              </a:extLst>
            </p:cNvPr>
            <p:cNvCxnSpPr/>
            <p:nvPr/>
          </p:nvCxnSpPr>
          <p:spPr>
            <a:xfrm>
              <a:off x="6196011" y="4028597"/>
              <a:ext cx="0" cy="77492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D2F0DDAC-368A-4471-BA7A-A1407393C30F}"/>
                </a:ext>
              </a:extLst>
            </p:cNvPr>
            <p:cNvCxnSpPr>
              <a:cxnSpLocks/>
            </p:cNvCxnSpPr>
            <p:nvPr/>
          </p:nvCxnSpPr>
          <p:spPr>
            <a:xfrm>
              <a:off x="6196011" y="4429461"/>
              <a:ext cx="111442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 Box 6">
              <a:extLst>
                <a:ext uri="{FF2B5EF4-FFF2-40B4-BE49-F238E27FC236}">
                  <a16:creationId xmlns:a16="http://schemas.microsoft.com/office/drawing/2014/main" id="{195EC200-F0CB-43B3-84CB-9B1FFEAC67F5}"/>
                </a:ext>
              </a:extLst>
            </p:cNvPr>
            <p:cNvSpPr txBox="1"/>
            <p:nvPr/>
          </p:nvSpPr>
          <p:spPr>
            <a:xfrm>
              <a:off x="7330716" y="2369276"/>
              <a:ext cx="1645920" cy="731520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090 non caregivers excluded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771189E1-4793-4A14-865B-EA52C20FECD2}"/>
                </a:ext>
              </a:extLst>
            </p:cNvPr>
            <p:cNvCxnSpPr/>
            <p:nvPr/>
          </p:nvCxnSpPr>
          <p:spPr>
            <a:xfrm>
              <a:off x="6152871" y="2752171"/>
              <a:ext cx="111442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25747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78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l Figure 1  Brief Figure Title: Study Participants Flow Chart Legend: Flow diagram of participants included in the study 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la Olapeju</dc:creator>
  <cp:lastModifiedBy>Bola Olapeju</cp:lastModifiedBy>
  <cp:revision>4</cp:revision>
  <dcterms:created xsi:type="dcterms:W3CDTF">2022-03-04T20:47:48Z</dcterms:created>
  <dcterms:modified xsi:type="dcterms:W3CDTF">2022-03-15T14:28:42Z</dcterms:modified>
</cp:coreProperties>
</file>